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60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2" d="100"/>
          <a:sy n="92" d="100"/>
        </p:scale>
        <p:origin x="-137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521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401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15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542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924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777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79683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004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88114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270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493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9E375-FB8F-4DEC-BE76-1D463BFD2569}" type="datetimeFigureOut">
              <a:rPr lang="en-US" smtClean="0"/>
              <a:t>7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36DEAC-29C8-49A1-9CF5-1773D6BFB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310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7.png"/><Relationship Id="rId3" Type="http://schemas.openxmlformats.org/officeDocument/2006/relationships/image" Target="../media/image22.png"/><Relationship Id="rId21" Type="http://schemas.openxmlformats.org/officeDocument/2006/relationships/image" Target="../media/image40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" Type="http://schemas.openxmlformats.org/officeDocument/2006/relationships/image" Target="../media/image21.png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10" Type="http://schemas.openxmlformats.org/officeDocument/2006/relationships/image" Target="../media/image29.png"/><Relationship Id="rId19" Type="http://schemas.openxmlformats.org/officeDocument/2006/relationships/image" Target="../media/image38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0DBF16F3-7973-4CB0-834E-5F03E56B58FB}"/>
              </a:ext>
            </a:extLst>
          </p:cNvPr>
          <p:cNvSpPr txBox="1"/>
          <p:nvPr/>
        </p:nvSpPr>
        <p:spPr>
          <a:xfrm flipH="1">
            <a:off x="1870745" y="845138"/>
            <a:ext cx="59048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resentative mice swimming path during the training trai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9C15036-1E80-47AC-B23D-1A7F115B3F27}"/>
              </a:ext>
            </a:extLst>
          </p:cNvPr>
          <p:cNvSpPr txBox="1"/>
          <p:nvPr/>
        </p:nvSpPr>
        <p:spPr>
          <a:xfrm>
            <a:off x="1687974" y="4073849"/>
            <a:ext cx="636613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1 Each image </a:t>
            </a:r>
            <a:r>
              <a:rPr lang="en-US" dirty="0" smtClean="0"/>
              <a:t>represents </a:t>
            </a:r>
            <a:r>
              <a:rPr lang="en-US" dirty="0"/>
              <a:t>the swimming path of individual </a:t>
            </a:r>
            <a:r>
              <a:rPr lang="en-US" dirty="0" smtClean="0"/>
              <a:t>mice.  </a:t>
            </a:r>
            <a:r>
              <a:rPr lang="en-US" dirty="0"/>
              <a:t>The training trail was conducted </a:t>
            </a:r>
            <a:r>
              <a:rPr lang="en-US" dirty="0" smtClean="0"/>
              <a:t>on the 5</a:t>
            </a:r>
            <a:r>
              <a:rPr lang="en-US" baseline="30000" dirty="0" smtClean="0"/>
              <a:t>th</a:t>
            </a:r>
            <a:r>
              <a:rPr lang="en-US" dirty="0" smtClean="0"/>
              <a:t> </a:t>
            </a:r>
            <a:r>
              <a:rPr lang="en-US" dirty="0"/>
              <a:t>day of training and at 6 months post </a:t>
            </a:r>
            <a:r>
              <a:rPr lang="en-US" dirty="0" err="1"/>
              <a:t>mTBI</a:t>
            </a:r>
            <a:r>
              <a:rPr lang="en-US" dirty="0"/>
              <a:t>.  Mice were released 180</a:t>
            </a:r>
            <a:r>
              <a:rPr lang="en-US" baseline="30000" dirty="0"/>
              <a:t>o</a:t>
            </a:r>
            <a:r>
              <a:rPr lang="en-US" dirty="0"/>
              <a:t>C from the correct quadrant.   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xmlns="" id="{45C8FA84-4D45-4A34-9A25-79A25DFBBBD7}"/>
              </a:ext>
            </a:extLst>
          </p:cNvPr>
          <p:cNvGrpSpPr/>
          <p:nvPr/>
        </p:nvGrpSpPr>
        <p:grpSpPr>
          <a:xfrm>
            <a:off x="2513934" y="1536894"/>
            <a:ext cx="5261624" cy="2285150"/>
            <a:chOff x="1557589" y="1358596"/>
            <a:chExt cx="5261624" cy="2285150"/>
          </a:xfrm>
        </p:grpSpPr>
        <p:pic>
          <p:nvPicPr>
            <p:cNvPr id="6" name="Picture 5" descr="A picture containing umbrella&#10;&#10;Description automatically generated">
              <a:extLst>
                <a:ext uri="{FF2B5EF4-FFF2-40B4-BE49-F238E27FC236}">
                  <a16:creationId xmlns:a16="http://schemas.microsoft.com/office/drawing/2014/main" xmlns="" id="{445650A2-369C-4240-893A-236632961AA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1093" y="1358596"/>
              <a:ext cx="1060541" cy="1055540"/>
            </a:xfrm>
            <a:prstGeom prst="rect">
              <a:avLst/>
            </a:prstGeom>
          </p:spPr>
        </p:pic>
        <p:pic>
          <p:nvPicPr>
            <p:cNvPr id="8" name="Picture 7" descr="A picture containing umbrella&#10;&#10;Description automatically generated">
              <a:extLst>
                <a:ext uri="{FF2B5EF4-FFF2-40B4-BE49-F238E27FC236}">
                  <a16:creationId xmlns:a16="http://schemas.microsoft.com/office/drawing/2014/main" xmlns="" id="{20CDD4BD-5C2A-4333-A8A4-4ABA24F97BD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21634" y="1358596"/>
              <a:ext cx="1045721" cy="105554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xmlns="" id="{8F76110C-42D8-4FD1-8B0E-535FFCEE0B4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59879" y="1358596"/>
              <a:ext cx="1068017" cy="1055540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xmlns="" id="{4E898443-3AF4-4C10-BCFC-3E571A7AE6F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718017" y="1358596"/>
              <a:ext cx="1048124" cy="1055540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E7D72038-2D52-4335-BC86-A00924C3633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766140" y="1358596"/>
              <a:ext cx="1053073" cy="1055540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xmlns="" id="{7AE2A3B1-C440-4091-BE33-015821545EC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557589" y="2578569"/>
              <a:ext cx="1065313" cy="1060358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xmlns="" id="{90497D26-C993-489F-A58B-2DF689EB9A4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614543" y="2578586"/>
              <a:ext cx="1062831" cy="1060341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xmlns="" id="{BE7969F3-43AA-4D4F-BEDB-CA2C10996CB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677374" y="2578587"/>
              <a:ext cx="1057869" cy="1060341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xmlns="" id="{371E803C-321F-4EDC-932B-37BC0376DA4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727896" y="2583388"/>
              <a:ext cx="1057869" cy="1060358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9DA6CBBD-C068-470E-ACD6-A9C736B06DC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771072" y="2583388"/>
              <a:ext cx="1048141" cy="1055540"/>
            </a:xfrm>
            <a:prstGeom prst="rect">
              <a:avLst/>
            </a:prstGeom>
          </p:spPr>
        </p:pic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15BA628B-EE85-461C-8A01-1484EC58DF92}"/>
              </a:ext>
            </a:extLst>
          </p:cNvPr>
          <p:cNvSpPr txBox="1"/>
          <p:nvPr/>
        </p:nvSpPr>
        <p:spPr>
          <a:xfrm>
            <a:off x="1644693" y="1879998"/>
            <a:ext cx="7072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a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B8E8341A-81F6-4A48-B903-0BBF975356EB}"/>
              </a:ext>
            </a:extLst>
          </p:cNvPr>
          <p:cNvSpPr txBox="1"/>
          <p:nvPr/>
        </p:nvSpPr>
        <p:spPr>
          <a:xfrm>
            <a:off x="1687974" y="3059668"/>
            <a:ext cx="6639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mTBI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5980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2D25BED0-769D-4C8C-8078-4A4C237636FF}"/>
              </a:ext>
            </a:extLst>
          </p:cNvPr>
          <p:cNvSpPr/>
          <p:nvPr/>
        </p:nvSpPr>
        <p:spPr>
          <a:xfrm>
            <a:off x="1577738" y="1256520"/>
            <a:ext cx="57045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Representative mice swimming path during the probe trail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36DC4B35-664D-44DE-8B54-4C72A02FBF4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0767" y="1918382"/>
            <a:ext cx="1050463" cy="105791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1705CDDE-BF85-4863-ACF7-82B9AA4EBD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69619" y="1918382"/>
            <a:ext cx="1067870" cy="105791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2CA7CC99-61EF-4801-949D-FB18E0D479A0}"/>
              </a:ext>
            </a:extLst>
          </p:cNvPr>
          <p:cNvSpPr txBox="1"/>
          <p:nvPr/>
        </p:nvSpPr>
        <p:spPr>
          <a:xfrm>
            <a:off x="1199625" y="2262672"/>
            <a:ext cx="7072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am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1608EAD1-6015-411A-AE95-E8A1EFDCA6C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61230" y="3246910"/>
            <a:ext cx="1060336" cy="105047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000E41F0-1413-406B-9773-9165CC4508A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29184" y="3255609"/>
            <a:ext cx="1040435" cy="103307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B271933E-A29E-425A-BDC4-1CE49186822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37489" y="3264308"/>
            <a:ext cx="1040401" cy="103307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90276E01-81E7-4B42-8F4A-63E3087E1FB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13749" y="3246910"/>
            <a:ext cx="1065376" cy="106787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xmlns="" id="{82FB3731-182D-43EB-B109-5F20D05432D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98398" y="1926761"/>
            <a:ext cx="1059481" cy="104953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xmlns="" id="{F11184F2-6285-427B-BF57-096CFBACC53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54268" y="1926760"/>
            <a:ext cx="1030666" cy="1049533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75F3E434-E32B-4FF2-85DB-56D33CD5D04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213749" y="1917952"/>
            <a:ext cx="1059481" cy="106447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xmlns="" id="{99F5D4AD-7D08-440E-B995-712FFF11676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314984" y="3246911"/>
            <a:ext cx="1042895" cy="1065084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3DEEF174-4928-4351-8786-3D58CCC41E23}"/>
              </a:ext>
            </a:extLst>
          </p:cNvPr>
          <p:cNvSpPr txBox="1"/>
          <p:nvPr/>
        </p:nvSpPr>
        <p:spPr>
          <a:xfrm>
            <a:off x="1221265" y="3585536"/>
            <a:ext cx="6639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mTBI</a:t>
            </a:r>
            <a:endParaRPr lang="en-US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xmlns="" id="{9C9D848C-C29E-4DD7-8570-CDB64312E8A9}"/>
              </a:ext>
            </a:extLst>
          </p:cNvPr>
          <p:cNvSpPr/>
          <p:nvPr/>
        </p:nvSpPr>
        <p:spPr>
          <a:xfrm>
            <a:off x="1221265" y="4561862"/>
            <a:ext cx="641752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. 2  Each image </a:t>
            </a:r>
            <a:r>
              <a:rPr lang="en-US" dirty="0" smtClean="0"/>
              <a:t>represents the swimming </a:t>
            </a:r>
            <a:r>
              <a:rPr lang="en-US" dirty="0"/>
              <a:t>path </a:t>
            </a:r>
            <a:r>
              <a:rPr lang="en-US" dirty="0"/>
              <a:t>of individual mice </a:t>
            </a:r>
            <a:r>
              <a:rPr lang="en-US" dirty="0" smtClean="0"/>
              <a:t>during the </a:t>
            </a:r>
            <a:r>
              <a:rPr lang="en-US" dirty="0"/>
              <a:t>30 second probe </a:t>
            </a:r>
            <a:r>
              <a:rPr lang="en-US" dirty="0" smtClean="0"/>
              <a:t>trial</a:t>
            </a:r>
            <a:r>
              <a:rPr lang="en-US" dirty="0"/>
              <a:t>, conducted 6 months post </a:t>
            </a:r>
            <a:r>
              <a:rPr lang="en-US" dirty="0" err="1"/>
              <a:t>mTBI</a:t>
            </a:r>
            <a:r>
              <a:rPr lang="en-US" dirty="0"/>
              <a:t>. The platform was removed during the probe </a:t>
            </a:r>
            <a:r>
              <a:rPr lang="en-US" dirty="0" smtClean="0"/>
              <a:t>trial</a:t>
            </a:r>
            <a:r>
              <a:rPr lang="en-US" dirty="0"/>
              <a:t>.  The red dot </a:t>
            </a:r>
            <a:r>
              <a:rPr lang="en-US" dirty="0" smtClean="0"/>
              <a:t>indicates </a:t>
            </a:r>
            <a:r>
              <a:rPr lang="en-US" dirty="0"/>
              <a:t>the correct quadrant of the training trial.  </a:t>
            </a:r>
          </a:p>
        </p:txBody>
      </p:sp>
    </p:spTree>
    <p:extLst>
      <p:ext uri="{BB962C8B-B14F-4D97-AF65-F5344CB8AC3E}">
        <p14:creationId xmlns:p14="http://schemas.microsoft.com/office/powerpoint/2010/main" val="12075272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xmlns="" id="{6915039B-2069-4498-988F-3E3A34E822A6}"/>
              </a:ext>
            </a:extLst>
          </p:cNvPr>
          <p:cNvSpPr/>
          <p:nvPr/>
        </p:nvSpPr>
        <p:spPr>
          <a:xfrm>
            <a:off x="1821767" y="370944"/>
            <a:ext cx="570870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Representative mice movement path during EPM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629FB125-C84B-43FE-B3A9-E369D7ABB558}"/>
              </a:ext>
            </a:extLst>
          </p:cNvPr>
          <p:cNvSpPr txBox="1"/>
          <p:nvPr/>
        </p:nvSpPr>
        <p:spPr>
          <a:xfrm>
            <a:off x="1078282" y="3956535"/>
            <a:ext cx="6639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mTBI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875F4F6D-6BBA-4C30-BCF2-E21B13CE56DF}"/>
              </a:ext>
            </a:extLst>
          </p:cNvPr>
          <p:cNvSpPr txBox="1"/>
          <p:nvPr/>
        </p:nvSpPr>
        <p:spPr>
          <a:xfrm>
            <a:off x="1098618" y="1833888"/>
            <a:ext cx="7072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am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xmlns="" id="{9D21D388-0077-4A8B-9871-8C6504C05696}"/>
              </a:ext>
            </a:extLst>
          </p:cNvPr>
          <p:cNvGrpSpPr/>
          <p:nvPr/>
        </p:nvGrpSpPr>
        <p:grpSpPr>
          <a:xfrm>
            <a:off x="1821767" y="3332926"/>
            <a:ext cx="5165564" cy="2183566"/>
            <a:chOff x="1697146" y="3639482"/>
            <a:chExt cx="5204936" cy="218356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4E969BD6-D120-45BE-90C1-1EA68CB8A00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05124" y="3640164"/>
              <a:ext cx="1012024" cy="106191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79A23D6F-9CC1-439F-B1EF-F63B8E886AF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42315" y="3640164"/>
              <a:ext cx="1003725" cy="1061912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xmlns="" id="{98945D87-EE32-4180-8CB0-A166D778ED4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78538" y="3640165"/>
              <a:ext cx="1038757" cy="1061912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xmlns="" id="{19B9E714-073F-449A-8BD2-311FEE01A13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850254" y="3640165"/>
              <a:ext cx="1012025" cy="1061912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xmlns="" id="{BD45B38E-C167-403A-B960-BA19CB7C70F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742314" y="4732966"/>
              <a:ext cx="1012025" cy="1081693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C468A4A5-0B56-439A-B1E6-770FFCF160F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886849" y="3639482"/>
              <a:ext cx="1012025" cy="106191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xmlns="" id="{14041100-E271-4C8C-9607-9DC84DB5548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697146" y="4732966"/>
              <a:ext cx="1012025" cy="1081693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xmlns="" id="{7885572B-FBCC-4E38-A447-1697801E53F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778538" y="4741355"/>
              <a:ext cx="1022959" cy="1081693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xmlns="" id="{270CFC45-72E4-451C-96FF-0D873035E029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841866" y="4741355"/>
              <a:ext cx="1016136" cy="1081693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xmlns="" id="{FE3F0734-771F-41AA-9D2B-EDEDBEB972D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879058" y="4743968"/>
              <a:ext cx="1023024" cy="1070692"/>
            </a:xfrm>
            <a:prstGeom prst="rect">
              <a:avLst/>
            </a:prstGeom>
          </p:spPr>
        </p:pic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xmlns="" id="{FA5C7D75-ADA0-4FE4-BAB2-55B1B6C97C05}"/>
              </a:ext>
            </a:extLst>
          </p:cNvPr>
          <p:cNvGrpSpPr/>
          <p:nvPr/>
        </p:nvGrpSpPr>
        <p:grpSpPr>
          <a:xfrm>
            <a:off x="1837455" y="946229"/>
            <a:ext cx="5165564" cy="2195894"/>
            <a:chOff x="1821767" y="1149296"/>
            <a:chExt cx="5165564" cy="2195894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xmlns="" id="{F68BA987-C2DD-4B3D-941C-A7EB3DBA772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821767" y="1149296"/>
              <a:ext cx="1022478" cy="1079546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764C6E38-9698-4502-99DA-195B9C800400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2859768" y="1149296"/>
              <a:ext cx="1006849" cy="1079546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xmlns="" id="{587B29FD-6A70-47EA-A8FA-F38CF7007F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893362" y="1149296"/>
              <a:ext cx="1003725" cy="1072325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E43335B1-D472-4AA9-ABB5-FAF9B17896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923652" y="1149297"/>
              <a:ext cx="1022479" cy="1073786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xmlns="" id="{01571332-9B50-417B-9CBE-D3DAE945FF10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5964307" y="1158506"/>
              <a:ext cx="1023024" cy="1067025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xmlns="" id="{82954DF8-11D1-4A02-AF5B-86BEF27BD4BA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1821767" y="2259732"/>
              <a:ext cx="1003726" cy="1076991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xmlns="" id="{234457A8-50A6-4F96-8A39-1E746D9BDB1E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2851379" y="2259732"/>
              <a:ext cx="1014289" cy="1076991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xmlns="" id="{9DA5C9A6-23DF-497A-810C-E076FD6B2191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893362" y="2259732"/>
              <a:ext cx="1022479" cy="1085458"/>
            </a:xfrm>
            <a:prstGeom prst="rect">
              <a:avLst/>
            </a:prstGeom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xmlns="" id="{EDDE791F-E4B5-4277-8105-8E754BC0C334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929886" y="2257715"/>
              <a:ext cx="1008713" cy="1077903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xmlns="" id="{A98A072C-DC3B-4AFB-B861-820698F50BA4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5958543" y="2257715"/>
              <a:ext cx="1008713" cy="1077903"/>
            </a:xfrm>
            <a:prstGeom prst="rect">
              <a:avLst/>
            </a:prstGeom>
          </p:spPr>
        </p:pic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59502EF2-B0CF-4B46-9DA2-BB7CC160FE15}"/>
              </a:ext>
            </a:extLst>
          </p:cNvPr>
          <p:cNvSpPr txBox="1"/>
          <p:nvPr/>
        </p:nvSpPr>
        <p:spPr>
          <a:xfrm>
            <a:off x="964370" y="5697086"/>
            <a:ext cx="664265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3  Each image </a:t>
            </a:r>
            <a:r>
              <a:rPr lang="en-US" dirty="0" smtClean="0"/>
              <a:t>represents the movement </a:t>
            </a:r>
            <a:r>
              <a:rPr lang="en-US" dirty="0"/>
              <a:t>path </a:t>
            </a:r>
            <a:r>
              <a:rPr lang="en-US" dirty="0" smtClean="0"/>
              <a:t>of individual mice during the EPM </a:t>
            </a:r>
            <a:r>
              <a:rPr lang="en-US" dirty="0"/>
              <a:t>test, conducted 9 weeks post </a:t>
            </a:r>
            <a:r>
              <a:rPr lang="en-US" dirty="0" err="1"/>
              <a:t>mTBI</a:t>
            </a:r>
            <a:r>
              <a:rPr lang="en-US" dirty="0"/>
              <a:t>. The horizontal bar is </a:t>
            </a:r>
            <a:r>
              <a:rPr lang="en-US" dirty="0" smtClean="0"/>
              <a:t>the closed </a:t>
            </a:r>
            <a:r>
              <a:rPr lang="en-US" dirty="0"/>
              <a:t>arm and vertical bar is </a:t>
            </a:r>
            <a:r>
              <a:rPr lang="en-US" dirty="0" smtClean="0"/>
              <a:t>the open </a:t>
            </a:r>
            <a:r>
              <a:rPr lang="en-US" dirty="0"/>
              <a:t>arm. </a:t>
            </a:r>
          </a:p>
        </p:txBody>
      </p:sp>
    </p:spTree>
    <p:extLst>
      <p:ext uri="{BB962C8B-B14F-4D97-AF65-F5344CB8AC3E}">
        <p14:creationId xmlns:p14="http://schemas.microsoft.com/office/powerpoint/2010/main" val="3609507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7</TotalTime>
  <Words>152</Words>
  <Application>Microsoft Office PowerPoint</Application>
  <PresentationFormat>On-screen Show (4:3)</PresentationFormat>
  <Paragraphs>12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, June</dc:creator>
  <cp:lastModifiedBy>Junezhou</cp:lastModifiedBy>
  <cp:revision>43</cp:revision>
  <dcterms:created xsi:type="dcterms:W3CDTF">2020-07-17T20:18:48Z</dcterms:created>
  <dcterms:modified xsi:type="dcterms:W3CDTF">2020-07-25T15:49:01Z</dcterms:modified>
</cp:coreProperties>
</file>